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9262972-84EE-4590-A66F-B70C590B2022}" v="8" dt="2025-07-28T20:17:05.7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4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7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ng, Yuyang" userId="624bfbdb-7781-46f6-b49b-a5fb0dad298f" providerId="ADAL" clId="{E9262972-84EE-4590-A66F-B70C590B2022}"/>
    <pc:docChg chg="addSld delSld modSld">
      <pc:chgData name="Tang, Yuyang" userId="624bfbdb-7781-46f6-b49b-a5fb0dad298f" providerId="ADAL" clId="{E9262972-84EE-4590-A66F-B70C590B2022}" dt="2025-07-28T20:17:05.707" v="10"/>
      <pc:docMkLst>
        <pc:docMk/>
      </pc:docMkLst>
      <pc:sldChg chg="modSp mod">
        <pc:chgData name="Tang, Yuyang" userId="624bfbdb-7781-46f6-b49b-a5fb0dad298f" providerId="ADAL" clId="{E9262972-84EE-4590-A66F-B70C590B2022}" dt="2025-07-28T20:17:05.707" v="10"/>
        <pc:sldMkLst>
          <pc:docMk/>
          <pc:sldMk cId="1840344110" sldId="256"/>
        </pc:sldMkLst>
        <pc:spChg chg="mod">
          <ac:chgData name="Tang, Yuyang" userId="624bfbdb-7781-46f6-b49b-a5fb0dad298f" providerId="ADAL" clId="{E9262972-84EE-4590-A66F-B70C590B2022}" dt="2025-07-28T20:17:05.707" v="10"/>
          <ac:spMkLst>
            <pc:docMk/>
            <pc:sldMk cId="1840344110" sldId="256"/>
            <ac:spMk id="8" creationId="{DD761D8F-A1EC-F8BF-7C76-8B1CF8F47311}"/>
          </ac:spMkLst>
        </pc:spChg>
      </pc:sldChg>
      <pc:sldChg chg="add del">
        <pc:chgData name="Tang, Yuyang" userId="624bfbdb-7781-46f6-b49b-a5fb0dad298f" providerId="ADAL" clId="{E9262972-84EE-4590-A66F-B70C590B2022}" dt="2025-07-28T19:54:15.269" v="7" actId="47"/>
        <pc:sldMkLst>
          <pc:docMk/>
          <pc:sldMk cId="1769367260" sldId="267"/>
        </pc:sldMkLst>
      </pc:sldChg>
      <pc:sldChg chg="add del">
        <pc:chgData name="Tang, Yuyang" userId="624bfbdb-7781-46f6-b49b-a5fb0dad298f" providerId="ADAL" clId="{E9262972-84EE-4590-A66F-B70C590B2022}" dt="2025-07-28T19:54:15.269" v="7" actId="47"/>
        <pc:sldMkLst>
          <pc:docMk/>
          <pc:sldMk cId="66985153" sldId="274"/>
        </pc:sldMkLst>
      </pc:sldChg>
      <pc:sldChg chg="add del">
        <pc:chgData name="Tang, Yuyang" userId="624bfbdb-7781-46f6-b49b-a5fb0dad298f" providerId="ADAL" clId="{E9262972-84EE-4590-A66F-B70C590B2022}" dt="2025-07-28T19:54:15.269" v="7" actId="47"/>
        <pc:sldMkLst>
          <pc:docMk/>
          <pc:sldMk cId="578676026" sldId="275"/>
        </pc:sldMkLst>
      </pc:sldChg>
      <pc:sldChg chg="add del">
        <pc:chgData name="Tang, Yuyang" userId="624bfbdb-7781-46f6-b49b-a5fb0dad298f" providerId="ADAL" clId="{E9262972-84EE-4590-A66F-B70C590B2022}" dt="2025-07-28T19:54:15.269" v="7" actId="47"/>
        <pc:sldMkLst>
          <pc:docMk/>
          <pc:sldMk cId="3008376714" sldId="279"/>
        </pc:sldMkLst>
      </pc:sldChg>
      <pc:sldChg chg="add del">
        <pc:chgData name="Tang, Yuyang" userId="624bfbdb-7781-46f6-b49b-a5fb0dad298f" providerId="ADAL" clId="{E9262972-84EE-4590-A66F-B70C590B2022}" dt="2025-07-28T19:54:15.269" v="7" actId="47"/>
        <pc:sldMkLst>
          <pc:docMk/>
          <pc:sldMk cId="416805864" sldId="290"/>
        </pc:sldMkLst>
      </pc:sldChg>
      <pc:sldChg chg="add del">
        <pc:chgData name="Tang, Yuyang" userId="624bfbdb-7781-46f6-b49b-a5fb0dad298f" providerId="ADAL" clId="{E9262972-84EE-4590-A66F-B70C590B2022}" dt="2025-07-28T19:54:15.269" v="7" actId="47"/>
        <pc:sldMkLst>
          <pc:docMk/>
          <pc:sldMk cId="3078378617" sldId="291"/>
        </pc:sldMkLst>
      </pc:sldChg>
      <pc:sldChg chg="add del">
        <pc:chgData name="Tang, Yuyang" userId="624bfbdb-7781-46f6-b49b-a5fb0dad298f" providerId="ADAL" clId="{E9262972-84EE-4590-A66F-B70C590B2022}" dt="2025-07-28T19:54:15.269" v="7" actId="47"/>
        <pc:sldMkLst>
          <pc:docMk/>
          <pc:sldMk cId="3954578830" sldId="29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479EDE-B31A-DBD9-D340-D22D034E5A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7BFC246-B216-5135-FE42-1B00652915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2ADF22-008A-F8DD-017F-4D86424C3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C2172D-F74D-C3BB-DB72-01190CD37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C0C5D3-230D-983C-AB41-B75B722BC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603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0B385-77C7-77BE-4CCE-A6D7CF6462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E39C11-5DFF-30DB-D3AB-ADD1544D7E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B9D67F-1FE9-76B8-3060-BF45CEB4B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F4C177-7423-C9AB-595C-C9870F393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6A3335-447F-70FD-F92D-4979A2CCF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8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2659A0-61DD-9F07-00F6-3FB4B17474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E7E710-1FC6-50C9-BFAB-1AA7214B8A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2992C-3766-CD48-CC10-503EAC13B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31E7F2-26AE-ADA3-4E7A-2829AD449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656ED3-975A-8AB4-7D59-33C435259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036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BF10D-28A6-EDA4-FAA0-7ABF390269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A05C52-3202-1B55-1E1B-7DAE45997B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6BB4DC-D48C-7B33-7EBB-0AD821127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98EC24-335F-C91B-DAF1-A9CBA7A7E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3CA4CB-E5CE-99AF-F369-E82760A1E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168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3055C3-CDB8-423C-F1A5-D6CC7E00A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E491F4-9C86-11CA-3C4C-B54E3D310D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0DBC43-AAAB-8C19-81A8-9C5B7171A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9F4EF0-662A-3CC2-2173-9D19100EF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099C10-B27F-B7BD-7969-33442F73D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668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854B8-CDB1-A4AC-19AB-0B97E22F9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60847E-B548-CF4D-B33B-3BDAC085A0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6C56E6-D280-073C-54B1-8684ECF3A3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8B60D0-CB3B-EB51-4F13-A3FCD7281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ECB9BD-DCBF-59EE-F658-4819C6EF0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BDD8EB-6269-C2C4-805A-D0F98B7E5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964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15396-6F73-7079-7787-96CF3E19F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0959BA-F1D1-8561-AB14-FF239020E7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0179A2-FEF0-2394-1FF7-2873C73284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80EF0C-57BF-6AA4-79D7-EC83C69285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502D1A-1D50-5331-47A4-3556DCD44F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88218E-B26F-D0EC-7958-AF066350C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BDD6E0-1A2B-F26E-84A7-1687B7713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23899C-D426-0BA5-162F-B95E856A8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071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75000-6D17-5659-76DF-F26488ADB5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CA2E1C-8D0D-EE9A-6682-5AE65CEC1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B9FAD5-7674-9790-A040-9D17AE86B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240CB0-9DD2-6CBD-64C6-87FAB47C8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193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90AD488-D223-4495-D3FC-6131E232A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6CF68C-F3F6-F089-3EDE-7DFDEC9D2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8BA657-1C21-51CA-13E4-0FB1E174C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939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1D774-DD32-2D57-6771-22D2480BD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DA0335-226C-6232-84C5-45C13C8777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2C5C07-EA60-CF7C-A638-F4A1A92EBA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FCF4FB-1D11-B247-0E55-4E8AD2A40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04F6F8-FF02-F5F1-8993-EC0D6D6B2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C58568-F987-0C73-2212-E2CAB4853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95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A6953-FC45-1DA3-9702-6E7D510F6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27D7850-0A0C-AC8F-512C-E6BAFAF2BA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AB8566-3431-C6EF-3507-8865C12268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369E7C-E54C-010C-354B-9109CB3C1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716C78-6CA3-1CB5-F0EF-AABD2DA6B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196B60-78C9-AD77-57C1-6A6B95477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515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645D10-BD9E-946B-2D07-928A38E8D0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F149F7-B81A-72C7-05CA-4FB535F3A0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C54DA0-CBA3-6257-37A7-FDD7FFD81A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264B40-060F-47FF-B74A-3E74AC0630A5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EA8E33-C61C-6C91-99BC-F1C29F438C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9A9D16-0B61-33CF-4439-226A7E6CCF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A281A1-7179-43AE-9CCF-630D77ACA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554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DD761D8F-A1EC-F8BF-7C76-8B1CF8F47311}"/>
              </a:ext>
            </a:extLst>
          </p:cNvPr>
          <p:cNvSpPr/>
          <p:nvPr/>
        </p:nvSpPr>
        <p:spPr>
          <a:xfrm>
            <a:off x="1172444" y="736570"/>
            <a:ext cx="528406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1 Table . Characteristics of the study cohort.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55EAF4FB-40FD-F64D-2573-AB0AEC1CB1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7221605"/>
              </p:ext>
            </p:extLst>
          </p:nvPr>
        </p:nvGraphicFramePr>
        <p:xfrm>
          <a:off x="1255568" y="1062181"/>
          <a:ext cx="7565158" cy="3842024"/>
        </p:xfrm>
        <a:graphic>
          <a:graphicData uri="http://schemas.openxmlformats.org/drawingml/2006/table">
            <a:tbl>
              <a:tblPr/>
              <a:tblGrid>
                <a:gridCol w="2290715">
                  <a:extLst>
                    <a:ext uri="{9D8B030D-6E8A-4147-A177-3AD203B41FA5}">
                      <a16:colId xmlns:a16="http://schemas.microsoft.com/office/drawing/2014/main" val="2394952450"/>
                    </a:ext>
                  </a:extLst>
                </a:gridCol>
                <a:gridCol w="970140">
                  <a:extLst>
                    <a:ext uri="{9D8B030D-6E8A-4147-A177-3AD203B41FA5}">
                      <a16:colId xmlns:a16="http://schemas.microsoft.com/office/drawing/2014/main" val="1899094853"/>
                    </a:ext>
                  </a:extLst>
                </a:gridCol>
                <a:gridCol w="1073205">
                  <a:extLst>
                    <a:ext uri="{9D8B030D-6E8A-4147-A177-3AD203B41FA5}">
                      <a16:colId xmlns:a16="http://schemas.microsoft.com/office/drawing/2014/main" val="2286311701"/>
                    </a:ext>
                  </a:extLst>
                </a:gridCol>
                <a:gridCol w="1352064">
                  <a:extLst>
                    <a:ext uri="{9D8B030D-6E8A-4147-A177-3AD203B41FA5}">
                      <a16:colId xmlns:a16="http://schemas.microsoft.com/office/drawing/2014/main" val="142943633"/>
                    </a:ext>
                  </a:extLst>
                </a:gridCol>
                <a:gridCol w="1879034">
                  <a:extLst>
                    <a:ext uri="{9D8B030D-6E8A-4147-A177-3AD203B41FA5}">
                      <a16:colId xmlns:a16="http://schemas.microsoft.com/office/drawing/2014/main" val="2184171107"/>
                    </a:ext>
                  </a:extLst>
                </a:gridCol>
              </a:tblGrid>
              <a:tr h="11200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WH</a:t>
                      </a:r>
                      <a:r>
                        <a:rPr lang="en-US" sz="1100" b="1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n ART</a:t>
                      </a: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 =2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63374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neg</a:t>
                      </a:r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100" b="1" i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 = 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AND (</a:t>
                      </a:r>
                      <a:r>
                        <a:rPr lang="en-US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 =8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(</a:t>
                      </a:r>
                      <a:r>
                        <a:rPr lang="en-US" sz="1100" b="1" i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 = 1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13933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 (n=1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/ANI (n=9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985610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(years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 (34-6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4 (32-5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3 (30-58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5 (27-64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712705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 (male, 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77.8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0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10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418187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e (</a:t>
                      </a:r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562059"/>
                  </a:ext>
                </a:extLst>
              </a:tr>
              <a:tr h="2149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ack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2.5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914348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8.9%)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75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4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9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909330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 C seropositive (</a:t>
                      </a:r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,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, 12.5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, 4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, 11.1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695007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ation of HIV infection (years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4-2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2-2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3-12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967467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R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76225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VL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,831 (400-135,64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,466 (&lt;400-750,00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,477 (0-750,00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751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(&lt; 400 copies/ml) *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.1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.3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006133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 (&lt; 400 copies/ml) *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7.5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.3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.3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53169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T use (</a:t>
                      </a:r>
                      <a:r>
                        <a:rPr lang="en-US" sz="1100" b="1" i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253143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 Protease inhibito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57.1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62.5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66.7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931404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 inhibitors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0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0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0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13455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ase inhibitors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4206964"/>
                  </a:ext>
                </a:extLst>
              </a:tr>
            </a:tbl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AD6EBB2D-CF76-C0D4-07C4-FC1322A67099}"/>
              </a:ext>
            </a:extLst>
          </p:cNvPr>
          <p:cNvSpPr/>
          <p:nvPr/>
        </p:nvSpPr>
        <p:spPr>
          <a:xfrm>
            <a:off x="1193464" y="4949889"/>
            <a:ext cx="772001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breviations: ART, antiretroviral therapy; RT, reverse transcriptase inhibitor. VL, viral loads. * Not all subjects have CSF VL available. One HAND+ donor and one HAND negative PLWH do not have plasma VL. NA, not available.</a:t>
            </a: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0344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30</Words>
  <Application>Microsoft Office PowerPoint</Application>
  <PresentationFormat>Widescreen</PresentationFormat>
  <Paragraphs>7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19:46:15Z</dcterms:created>
  <dcterms:modified xsi:type="dcterms:W3CDTF">2025-07-28T20:17:07Z</dcterms:modified>
</cp:coreProperties>
</file>